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Override PartName="/ppt/slides/slide11.xml" ContentType="application/vnd.openxmlformats-officedocument.presentationml.slide+xml"/>
  <Default Extension="xml" ContentType="application/xml"/>
  <Override PartName="/ppt/slides/slide9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notesSlides/notesSlide1.xml" ContentType="application/vnd.openxmlformats-officedocument.presentationml.notes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theme/theme2.xml" ContentType="application/vnd.openxmlformats-officedocument.them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notesSlides/notesSlide2.xml" ContentType="application/vnd.openxmlformats-officedocument.presentationml.notesSlide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13"/>
  </p:notesMasterIdLst>
  <p:sldIdLst>
    <p:sldId id="258" r:id="rId2"/>
    <p:sldId id="263" r:id="rId3"/>
    <p:sldId id="262" r:id="rId4"/>
    <p:sldId id="261" r:id="rId5"/>
    <p:sldId id="260" r:id="rId6"/>
    <p:sldId id="257" r:id="rId7"/>
    <p:sldId id="256" r:id="rId8"/>
    <p:sldId id="259" r:id="rId9"/>
    <p:sldId id="264" r:id="rId10"/>
    <p:sldId id="265" r:id="rId11"/>
    <p:sldId id="266" r:id="rId1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288" y="-3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interSettings" Target="printerSettings/printerSettings1.bin"/><Relationship Id="rId15" Type="http://schemas.openxmlformats.org/officeDocument/2006/relationships/presProps" Target="presProps.xml"/><Relationship Id="rId16" Type="http://schemas.openxmlformats.org/officeDocument/2006/relationships/viewProps" Target="viewProps.xml"/><Relationship Id="rId17" Type="http://schemas.openxmlformats.org/officeDocument/2006/relationships/theme" Target="theme/theme1.xml"/><Relationship Id="rId1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039FD1-2412-4314-8204-D2219337B3FE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EA378C-38B8-4E7A-8365-51253B3C269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EA378C-38B8-4E7A-8365-51253B3C269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EA378C-38B8-4E7A-8365-51253B3C2694}" type="slidenum">
              <a:rPr lang="zh-CN" altLang="en-US" smtClean="0"/>
              <a:pPr/>
              <a:t>10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6/30/1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0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组合 38"/>
          <p:cNvGrpSpPr/>
          <p:nvPr/>
        </p:nvGrpSpPr>
        <p:grpSpPr>
          <a:xfrm>
            <a:off x="142852" y="-32"/>
            <a:ext cx="6544892" cy="8815252"/>
            <a:chOff x="115218" y="114466"/>
            <a:chExt cx="6544892" cy="8815252"/>
          </a:xfrm>
        </p:grpSpPr>
        <p:pic>
          <p:nvPicPr>
            <p:cNvPr id="3" name="图片 2" descr="Figure S1-1副本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728" y="114466"/>
              <a:ext cx="6233248" cy="8815252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 rot="1985489">
              <a:off x="115389" y="2404304"/>
              <a:ext cx="74251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let-7g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722990" y="2442950"/>
              <a:ext cx="918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a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1310761" y="2476288"/>
              <a:ext cx="918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a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1825116" y="2442573"/>
              <a:ext cx="91897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b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2500745" y="2445139"/>
              <a:ext cx="92698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b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3303203" y="2389124"/>
              <a:ext cx="7218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3928379" y="2405910"/>
              <a:ext cx="72180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4512059" y="2407941"/>
              <a:ext cx="7907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a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5225789" y="2410130"/>
              <a:ext cx="79874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b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5869381" y="2407942"/>
              <a:ext cx="7907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c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120354" y="5267650"/>
              <a:ext cx="79874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708555" y="5395100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3b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1351497" y="5395101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3b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2019336" y="5347201"/>
              <a:ext cx="79874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2663547" y="5348613"/>
              <a:ext cx="798745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7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3181186" y="530770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87b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3748278" y="5267650"/>
              <a:ext cx="86767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2a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4458649" y="533908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2b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5011103" y="526765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0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5648176" y="528865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2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115218" y="833948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2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758162" y="83394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3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1329665" y="826804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3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1866705" y="8339484"/>
              <a:ext cx="9446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84a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 rot="1985489">
              <a:off x="2434202" y="833948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84b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 rot="1985489">
              <a:off x="3115615" y="83394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9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 rot="1985489">
              <a:off x="3758557" y="83394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9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 rot="1985489">
              <a:off x="4401500" y="83394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1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 rot="1985489">
              <a:off x="4973003" y="83394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1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 rot="1985489">
              <a:off x="5623263" y="8268047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5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1" name="矩形 40"/>
          <p:cNvSpPr/>
          <p:nvPr/>
        </p:nvSpPr>
        <p:spPr>
          <a:xfrm>
            <a:off x="76200" y="8698468"/>
            <a:ext cx="113583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0" name="组合 59"/>
          <p:cNvGrpSpPr/>
          <p:nvPr/>
        </p:nvGrpSpPr>
        <p:grpSpPr>
          <a:xfrm>
            <a:off x="0" y="-1"/>
            <a:ext cx="6866443" cy="9144001"/>
            <a:chOff x="0" y="-1"/>
            <a:chExt cx="6866443" cy="9144001"/>
          </a:xfrm>
        </p:grpSpPr>
        <p:sp>
          <p:nvSpPr>
            <p:cNvPr id="27" name="矩形 26"/>
            <p:cNvSpPr/>
            <p:nvPr/>
          </p:nvSpPr>
          <p:spPr>
            <a:xfrm>
              <a:off x="0" y="8774668"/>
              <a:ext cx="18473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endParaRPr lang="zh-CN" altLang="en-US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28" name="图片 27" descr="未标题-1副本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85728" y="-1"/>
              <a:ext cx="6286544" cy="8890625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 rot="1811191">
              <a:off x="254118" y="2823145"/>
              <a:ext cx="8078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 rot="1811191">
              <a:off x="843171" y="2769736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0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rot="1811191">
              <a:off x="76536" y="558369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0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811191">
              <a:off x="1504300" y="2679603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811191">
              <a:off x="2147242" y="2679602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2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811191">
              <a:off x="2790183" y="2679603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3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811191">
              <a:off x="3218812" y="2608165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811191">
              <a:off x="3861753" y="2679603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811191">
              <a:off x="4504695" y="2679602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811191">
              <a:off x="5076199" y="2608165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8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811191">
              <a:off x="5677259" y="2632229"/>
              <a:ext cx="1080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19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811191">
              <a:off x="290071" y="8586284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0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811191">
              <a:off x="933013" y="5536318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811191">
              <a:off x="1647393" y="546488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2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811191">
              <a:off x="2433212" y="560775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3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811191">
              <a:off x="3004714" y="560775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4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811191">
              <a:off x="3433343" y="5607755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811191">
              <a:off x="3933408" y="5607755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 rot="1811191">
              <a:off x="4504913" y="5607754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 rot="1811191">
              <a:off x="5076417" y="553631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8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 rot="1811191">
              <a:off x="5776504" y="546488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29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811191">
              <a:off x="1075890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811191">
              <a:off x="1647393" y="8586284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2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 rot="1811191">
              <a:off x="2218897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3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 rot="1811191">
              <a:off x="2861838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4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 rot="1811191">
              <a:off x="4147722" y="8586284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 rot="1811191">
              <a:off x="3433344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811191">
              <a:off x="5362170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4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 rot="1811191">
              <a:off x="4719226" y="85862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13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 rot="1811191">
              <a:off x="5789289" y="849009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3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组合 28"/>
          <p:cNvGrpSpPr/>
          <p:nvPr/>
        </p:nvGrpSpPr>
        <p:grpSpPr>
          <a:xfrm>
            <a:off x="504385" y="0"/>
            <a:ext cx="6435004" cy="8487300"/>
            <a:chOff x="504385" y="0"/>
            <a:chExt cx="6435004" cy="8487300"/>
          </a:xfrm>
        </p:grpSpPr>
        <p:pic>
          <p:nvPicPr>
            <p:cNvPr id="3" name="图片 2" descr="未标题-2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571480" y="0"/>
              <a:ext cx="5876059" cy="8310104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811191">
              <a:off x="504385" y="253592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811191">
              <a:off x="1147327" y="260736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811191">
              <a:off x="1790269" y="2607359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8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811191">
              <a:off x="2433212" y="2678798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39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811191">
              <a:off x="2861839" y="253592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0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811191">
              <a:off x="3576219" y="253592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811191">
              <a:off x="4219161" y="253592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2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811191">
              <a:off x="4790665" y="253592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3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11191">
              <a:off x="5862235" y="253592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811191">
              <a:off x="5290731" y="253592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4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811191">
              <a:off x="504386" y="575063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811191">
              <a:off x="647260" y="817952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6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811191">
              <a:off x="1075889" y="5750632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811191">
              <a:off x="1575955" y="575063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8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811191">
              <a:off x="2147459" y="575063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49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811191">
              <a:off x="2718962" y="575063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0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811191">
              <a:off x="3290467" y="575063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1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811191">
              <a:off x="4076285" y="5822070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2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811191">
              <a:off x="4647790" y="5822069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3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811191">
              <a:off x="5290730" y="5822069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4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 rot="1811191">
              <a:off x="5776502" y="5750631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5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 rot="1811191">
              <a:off x="1504517" y="8179523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7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811191">
              <a:off x="2290334" y="8179523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8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811191">
              <a:off x="3219030" y="8108086"/>
              <a:ext cx="10771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 smtClean="0">
                  <a:latin typeface="Times New Roman" pitchFamily="18" charset="0"/>
                  <a:cs typeface="Times New Roman" pitchFamily="18" charset="0"/>
                </a:rPr>
                <a:t>lst-mir-n259</a:t>
              </a:r>
              <a:endParaRPr lang="zh-CN" altLang="en-US" sz="14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0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258097" y="142844"/>
            <a:ext cx="6605703" cy="8512164"/>
            <a:chOff x="258097" y="142844"/>
            <a:chExt cx="6605703" cy="8512164"/>
          </a:xfrm>
        </p:grpSpPr>
        <p:pic>
          <p:nvPicPr>
            <p:cNvPr id="2" name="图片 1" descr="Figure S1-3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428604" y="142844"/>
              <a:ext cx="6018935" cy="8512164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439445" y="2553007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 rot="1985489">
              <a:off x="5859871" y="8252621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9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5137711" y="8181183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8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4566207" y="8181182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8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4005103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3433600" y="821761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2147716" y="814617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2719219" y="814617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1647649" y="814617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972475" y="8125169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258097" y="812517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3219285" y="536009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2076277" y="536009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2647781" y="536009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1576212" y="536009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933270" y="528865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290790" y="5287097"/>
              <a:ext cx="86998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3862227" y="536009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4433731" y="536009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5648177" y="528865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1010947" y="2553005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1653888" y="2553005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2153956" y="2553005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5120479" y="536429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2796897" y="2553005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3368402" y="2553006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3868467" y="2481567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4439971" y="2481567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5082914" y="2553006"/>
              <a:ext cx="79874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5648178" y="257401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-5801" y="0"/>
            <a:ext cx="6743981" cy="8815254"/>
            <a:chOff x="-5801" y="0"/>
            <a:chExt cx="6743981" cy="8815254"/>
          </a:xfrm>
        </p:grpSpPr>
        <p:pic>
          <p:nvPicPr>
            <p:cNvPr id="2" name="图片 1" descr="Figure S1-4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96147" y="0"/>
              <a:ext cx="6233249" cy="8815254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-5801" y="2180391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9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 rot="1985489">
              <a:off x="494241" y="2180391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9-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4599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1147584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576080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1790525" y="821761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2362029" y="821761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2933533" y="821761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3505037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4219418" y="821761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4933797" y="828905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5576738" y="828905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3076410" y="507434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2362029" y="500290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1719087" y="500290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1219021" y="500290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647517" y="500290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76014" y="500290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1004707" y="214538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1576210" y="214538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2290591" y="214538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2862095" y="214538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3505036" y="221682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4147979" y="214538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3862226" y="507434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4862359" y="207814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4505169" y="507434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5148111" y="507434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5862491" y="507434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4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5719615" y="214538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3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285728" y="0"/>
            <a:ext cx="6424821" cy="8668319"/>
            <a:chOff x="76013" y="0"/>
            <a:chExt cx="6777388" cy="9144000"/>
          </a:xfrm>
        </p:grpSpPr>
        <p:pic>
          <p:nvPicPr>
            <p:cNvPr id="2" name="图片 1" descr="Figure S1-5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96147" y="0"/>
              <a:ext cx="6465705" cy="9144000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147452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 rot="1985489">
              <a:off x="5977712" y="850336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5290987" y="850336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4576607" y="843192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4053681" y="8477647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3290724" y="843192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2647781" y="843192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2076278" y="843192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1361896" y="8431927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764675" y="843192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76013" y="836048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94111" y="5510589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790392" y="550296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2004839" y="550296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1433334" y="550296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2647781" y="5502969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4076541" y="5431530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3290723" y="5431531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4862360" y="5502969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5433862" y="5502967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5977712" y="5502968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7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790393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5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1504773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2147715" y="250257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2862095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3505038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4219417" y="250257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4790922" y="250257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5433863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5909133" y="2438756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6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组合 41"/>
          <p:cNvGrpSpPr/>
          <p:nvPr/>
        </p:nvGrpSpPr>
        <p:grpSpPr>
          <a:xfrm>
            <a:off x="190980" y="0"/>
            <a:ext cx="6519291" cy="8587534"/>
            <a:chOff x="76013" y="0"/>
            <a:chExt cx="6519291" cy="8587534"/>
          </a:xfrm>
        </p:grpSpPr>
        <p:pic>
          <p:nvPicPr>
            <p:cNvPr id="2" name="图片 1" descr="Figure S1-6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14290" y="0"/>
              <a:ext cx="6072229" cy="8587534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76013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108979" y="8074736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609045" y="8074737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1213244" y="8094184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1856648" y="8164063"/>
              <a:ext cx="94122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2499128" y="8165621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3713574" y="8165621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3070632" y="8165622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4346115" y="8200631"/>
              <a:ext cx="10751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5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76013" y="528865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647517" y="528865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1212781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1784285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2427227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3070169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3713111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603068" y="248828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8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1219022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1790525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2414417" y="250733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3147847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3862228" y="250257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4505169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5719615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5148112" y="2502572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9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4917619" y="8200630"/>
              <a:ext cx="107516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5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5642399" y="8237060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4284615" y="530965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4927556" y="530965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 rot="1985489">
              <a:off x="5641938" y="53096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0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213111" y="214282"/>
            <a:ext cx="6412727" cy="8358246"/>
            <a:chOff x="213111" y="214282"/>
            <a:chExt cx="6412727" cy="8358246"/>
          </a:xfrm>
        </p:grpSpPr>
        <p:pic>
          <p:nvPicPr>
            <p:cNvPr id="2" name="图片 1" descr="Figure S1-7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57166" y="214282"/>
              <a:ext cx="5910100" cy="8358246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213111" y="2522018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 rot="1985489">
              <a:off x="784615" y="2593457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1284681" y="2522020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1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1924769" y="252202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2639150" y="259345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3284483" y="259501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3855987" y="2595016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4498929" y="266645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5141872" y="266645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5641937" y="266645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3424968" y="545097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2752667" y="545253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5678912" y="8184671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5139479" y="823705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4567977" y="823706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3925034" y="816562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3353530" y="81656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2716938" y="817197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2139084" y="817197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1496143" y="81656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851608" y="817351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294396" y="821800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2067646" y="537954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1498534" y="5381097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853201" y="537954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284549" y="5379539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2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4038551" y="543983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5641937" y="5452536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4570367" y="5452536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5141871" y="545253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3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5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组合 38"/>
          <p:cNvGrpSpPr/>
          <p:nvPr/>
        </p:nvGrpSpPr>
        <p:grpSpPr>
          <a:xfrm>
            <a:off x="281696" y="1"/>
            <a:ext cx="6365304" cy="8572527"/>
            <a:chOff x="281696" y="1"/>
            <a:chExt cx="6577482" cy="8858280"/>
          </a:xfrm>
        </p:grpSpPr>
        <p:pic>
          <p:nvPicPr>
            <p:cNvPr id="8" name="图片 7" descr="Figure S1-8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85728" y="1"/>
              <a:ext cx="6263673" cy="8858280"/>
            </a:xfrm>
            <a:prstGeom prst="rect">
              <a:avLst/>
            </a:prstGeom>
          </p:spPr>
        </p:pic>
        <p:sp>
          <p:nvSpPr>
            <p:cNvPr id="9" name="矩形 8"/>
            <p:cNvSpPr/>
            <p:nvPr/>
          </p:nvSpPr>
          <p:spPr>
            <a:xfrm rot="1985489">
              <a:off x="284549" y="2379145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836541" y="233466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1569971" y="238070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4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2141475" y="238070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2719330" y="236958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3320191" y="239184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3853596" y="238073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4417162" y="236644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5060104" y="238549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5713838" y="2379143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5912252" y="8379936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2853464" y="537954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5373647" y="838149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4721964" y="838310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4070301" y="838149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3427358" y="838149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2784417" y="838149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2212913" y="838149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1569970" y="838149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927029" y="838149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281696" y="837993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2284351" y="5381097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1710456" y="537954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1030217" y="537315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 rot="1985489">
              <a:off x="353133" y="537954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5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4" name="矩形 33"/>
            <p:cNvSpPr/>
            <p:nvPr/>
          </p:nvSpPr>
          <p:spPr>
            <a:xfrm rot="1985489">
              <a:off x="3435297" y="535411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5" name="矩形 34"/>
            <p:cNvSpPr/>
            <p:nvPr/>
          </p:nvSpPr>
          <p:spPr>
            <a:xfrm rot="1985489">
              <a:off x="4067910" y="537953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6" name="矩形 35"/>
            <p:cNvSpPr/>
            <p:nvPr/>
          </p:nvSpPr>
          <p:spPr>
            <a:xfrm rot="1985489">
              <a:off x="4679101" y="533985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7" name="矩形 36"/>
            <p:cNvSpPr/>
            <p:nvPr/>
          </p:nvSpPr>
          <p:spPr>
            <a:xfrm rot="1985489">
              <a:off x="5256955" y="533985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8" name="矩形 37"/>
            <p:cNvSpPr/>
            <p:nvPr/>
          </p:nvSpPr>
          <p:spPr>
            <a:xfrm rot="1985489">
              <a:off x="5795121" y="530016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6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1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组合 33"/>
          <p:cNvGrpSpPr/>
          <p:nvPr/>
        </p:nvGrpSpPr>
        <p:grpSpPr>
          <a:xfrm>
            <a:off x="295199" y="0"/>
            <a:ext cx="6450142" cy="8714224"/>
            <a:chOff x="295199" y="0"/>
            <a:chExt cx="6450142" cy="8714224"/>
          </a:xfrm>
        </p:grpSpPr>
        <p:pic>
          <p:nvPicPr>
            <p:cNvPr id="2" name="图片 1" descr="Figure S1-9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57166" y="0"/>
              <a:ext cx="6161811" cy="8714224"/>
            </a:xfrm>
            <a:prstGeom prst="rect">
              <a:avLst/>
            </a:prstGeom>
          </p:spPr>
        </p:pic>
        <p:sp>
          <p:nvSpPr>
            <p:cNvPr id="3" name="矩形 2"/>
            <p:cNvSpPr/>
            <p:nvPr/>
          </p:nvSpPr>
          <p:spPr>
            <a:xfrm rot="1985489">
              <a:off x="295199" y="239975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" name="矩形 3"/>
            <p:cNvSpPr/>
            <p:nvPr/>
          </p:nvSpPr>
          <p:spPr>
            <a:xfrm rot="1985489">
              <a:off x="5785276" y="5236663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 rot="1985489">
              <a:off x="1569971" y="523822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1466782" y="238070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855591" y="238070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7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981006" y="52382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424572" y="523666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2029546" y="232040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5744000" y="2320406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2724876" y="229976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5164881" y="233310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3445606" y="230770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4093310" y="234104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4645764" y="232834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8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2782026" y="523666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5792708" y="8148129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6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5185518" y="813387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4606075" y="811958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4077434" y="8122757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2893955" y="809574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3520218" y="810053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1712847" y="809574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" name="矩形 25"/>
            <p:cNvSpPr/>
            <p:nvPr/>
          </p:nvSpPr>
          <p:spPr>
            <a:xfrm rot="1985489">
              <a:off x="1036565" y="809574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 rot="1985489">
              <a:off x="2355789" y="809574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 rot="1985489">
              <a:off x="426963" y="809574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 rot="1985489">
              <a:off x="2120034" y="5203326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 rot="1985489">
              <a:off x="3344004" y="521126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1" name="矩形 30"/>
            <p:cNvSpPr/>
            <p:nvPr/>
          </p:nvSpPr>
          <p:spPr>
            <a:xfrm rot="1985489">
              <a:off x="3928210" y="5230313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3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 rot="1985489">
              <a:off x="4567977" y="5236665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4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33" name="矩形 32"/>
            <p:cNvSpPr/>
            <p:nvPr/>
          </p:nvSpPr>
          <p:spPr>
            <a:xfrm rot="1985489">
              <a:off x="5139479" y="5236664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just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19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36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37051" y="214282"/>
            <a:ext cx="6440534" cy="8688565"/>
            <a:chOff x="137051" y="214282"/>
            <a:chExt cx="6440534" cy="8688565"/>
          </a:xfrm>
        </p:grpSpPr>
        <p:pic>
          <p:nvPicPr>
            <p:cNvPr id="2" name="图片 1" descr="Figure S1-2副本.jpg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57166" y="214282"/>
              <a:ext cx="6143668" cy="8688565"/>
            </a:xfrm>
            <a:prstGeom prst="rect">
              <a:avLst/>
            </a:prstGeom>
          </p:spPr>
        </p:pic>
        <p:sp>
          <p:nvSpPr>
            <p:cNvPr id="5" name="矩形 4"/>
            <p:cNvSpPr/>
            <p:nvPr/>
          </p:nvSpPr>
          <p:spPr>
            <a:xfrm rot="1985489">
              <a:off x="137051" y="2466144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5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" name="矩形 5"/>
            <p:cNvSpPr/>
            <p:nvPr/>
          </p:nvSpPr>
          <p:spPr>
            <a:xfrm rot="1985489">
              <a:off x="1494373" y="2466143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6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 rot="1985489">
              <a:off x="2219153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" name="矩形 7"/>
            <p:cNvSpPr/>
            <p:nvPr/>
          </p:nvSpPr>
          <p:spPr>
            <a:xfrm rot="1985489">
              <a:off x="2761322" y="2494718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9d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" name="矩形 8"/>
            <p:cNvSpPr/>
            <p:nvPr/>
          </p:nvSpPr>
          <p:spPr>
            <a:xfrm rot="1985489">
              <a:off x="3280324" y="2466142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81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" name="矩形 9"/>
            <p:cNvSpPr/>
            <p:nvPr/>
          </p:nvSpPr>
          <p:spPr>
            <a:xfrm rot="1985489">
              <a:off x="3994704" y="2537580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81-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" name="矩形 10"/>
            <p:cNvSpPr/>
            <p:nvPr/>
          </p:nvSpPr>
          <p:spPr>
            <a:xfrm rot="1985489">
              <a:off x="4576608" y="250257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30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" name="矩形 11"/>
            <p:cNvSpPr/>
            <p:nvPr/>
          </p:nvSpPr>
          <p:spPr>
            <a:xfrm rot="1985489">
              <a:off x="5148111" y="2502574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31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" name="矩形 12"/>
            <p:cNvSpPr/>
            <p:nvPr/>
          </p:nvSpPr>
          <p:spPr>
            <a:xfrm rot="1985489">
              <a:off x="5701896" y="2466143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31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" name="矩形 13"/>
            <p:cNvSpPr/>
            <p:nvPr/>
          </p:nvSpPr>
          <p:spPr>
            <a:xfrm rot="1985489">
              <a:off x="3448847" y="8252620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1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" name="矩形 14"/>
            <p:cNvSpPr/>
            <p:nvPr/>
          </p:nvSpPr>
          <p:spPr>
            <a:xfrm rot="1985489">
              <a:off x="2826089" y="8238333"/>
              <a:ext cx="9469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1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" name="矩形 15"/>
            <p:cNvSpPr/>
            <p:nvPr/>
          </p:nvSpPr>
          <p:spPr>
            <a:xfrm rot="1985489">
              <a:off x="2275544" y="827167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1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" name="矩形 16"/>
            <p:cNvSpPr/>
            <p:nvPr/>
          </p:nvSpPr>
          <p:spPr>
            <a:xfrm rot="1985489">
              <a:off x="1091394" y="82526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8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 rot="1985489">
              <a:off x="1662897" y="82526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 rot="1985489">
              <a:off x="448452" y="8252621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n207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 rot="1985489">
              <a:off x="2129996" y="525222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65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 rot="1985489">
              <a:off x="1504773" y="528865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32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 rot="1985489">
              <a:off x="790393" y="5288655"/>
              <a:ext cx="87568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29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 rot="1985489">
              <a:off x="166707" y="5323663"/>
              <a:ext cx="9446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927a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 rot="1985489">
              <a:off x="779992" y="2466143"/>
              <a:ext cx="1003929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276-1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 rot="1985489">
              <a:off x="2805905" y="5323662"/>
              <a:ext cx="95263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 fontAlgn="ctr"/>
              <a:r>
                <a:rPr lang="en-US" sz="1200" dirty="0" smtClean="0">
                  <a:solidFill>
                    <a:srgbClr val="000000"/>
                  </a:solidFill>
                  <a:latin typeface="Times New Roman"/>
                </a:rPr>
                <a:t>lst-mir-1000</a:t>
              </a:r>
              <a:endParaRPr lang="en-US" sz="1200" dirty="0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7" name="矩形 40"/>
          <p:cNvSpPr/>
          <p:nvPr/>
        </p:nvSpPr>
        <p:spPr>
          <a:xfrm>
            <a:off x="76200" y="8698468"/>
            <a:ext cx="229642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S2 (</a:t>
            </a:r>
            <a:r>
              <a:rPr lang="en-US" altLang="zh-CN" b="1" i="1" dirty="0" smtClean="0">
                <a:latin typeface="Times New Roman" pitchFamily="18" charset="0"/>
                <a:cs typeface="Times New Roman" pitchFamily="18" charset="0"/>
              </a:rPr>
              <a:t>continued</a:t>
            </a:r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zh-CN" altLang="en-US" b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1667</Words>
  <Application>Microsoft Macintosh PowerPoint</Application>
  <PresentationFormat>On-screen Show (4:3)</PresentationFormat>
  <Paragraphs>328</Paragraphs>
  <Slides>11</Slides>
  <Notes>2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主题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Jianhong Xu</cp:lastModifiedBy>
  <cp:revision>22</cp:revision>
  <dcterms:created xsi:type="dcterms:W3CDTF">2014-06-30T14:09:21Z</dcterms:created>
  <dcterms:modified xsi:type="dcterms:W3CDTF">2014-06-30T14:12:53Z</dcterms:modified>
</cp:coreProperties>
</file>